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1106280" y="812880"/>
            <a:ext cx="5343480" cy="400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4"/>
          </p:nvPr>
        </p:nvSpPr>
        <p:spPr>
          <a:xfrm>
            <a:off x="4277880" y="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1015668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27788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A1865C83-8A1C-4213-B75E-01440CE290FC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498DE823-C3C5-4D83-AD40-6B5133DEC00C}" type="slidenum">
              <a:rPr b="0" lang="fr-FR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4920" cy="400824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DB9D8-519B-416E-9A8B-D89EAE39D6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2920" y="437400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62122-3FA4-41CA-8293-56A94030E6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505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27F18-9F13-4640-A7B0-FB77F3EC7C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552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292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552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6FFE9-9E31-4CB0-B881-E220CD6489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C4FEA-35C7-420C-9897-D23A82BCE5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7EF94-AD49-438B-8774-1555A3BEB1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A4E4D0-F94D-4002-B811-871C7238D4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975BC2-2A50-47B5-90A1-1ACD9E1AF9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2920" y="301320"/>
            <a:ext cx="9069480" cy="584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5C3D8-3D52-48B4-8D25-5C0017EF94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677DF7-FF4D-4763-A234-3B4E5B15EE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505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77235-BDF6-4065-BD58-7D30225BB5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8EFED-92F3-4610-96C5-6F7483262B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440"/>
            <a:ext cx="234612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440"/>
            <a:ext cx="319392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7720" y="6886440"/>
            <a:ext cx="234648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6A3384C7-D30E-4021-B1C5-9E8A20C817AF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AutoShape 1"/>
          <p:cNvSpPr/>
          <p:nvPr/>
        </p:nvSpPr>
        <p:spPr>
          <a:xfrm>
            <a:off x="644400" y="5565600"/>
            <a:ext cx="3705480" cy="936720"/>
          </a:xfrm>
          <a:prstGeom prst="roundRect">
            <a:avLst>
              <a:gd name="adj" fmla="val 167"/>
            </a:avLst>
          </a:prstGeom>
          <a:noFill/>
          <a:ln w="6336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960" bIns="45000" anchor="ctr">
            <a:normAutofit/>
          </a:bodyPr>
          <a:p>
            <a:pPr algn="ctr">
              <a:lnSpc>
                <a:spcPct val="92000"/>
              </a:lnSpc>
              <a:tabLst>
                <a:tab algn="l" pos="0"/>
                <a:tab algn="l" pos="355680"/>
                <a:tab algn="l" pos="711360"/>
                <a:tab algn="l" pos="1065240"/>
                <a:tab algn="l" pos="1420920"/>
                <a:tab algn="l" pos="1778040"/>
                <a:tab algn="l" pos="2133720"/>
                <a:tab algn="l" pos="2487600"/>
                <a:tab algn="l" pos="2843280"/>
                <a:tab algn="l" pos="3200400"/>
                <a:tab algn="l" pos="3556080"/>
                <a:tab algn="l" pos="3911760"/>
                <a:tab algn="l" pos="426564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fr-FR" sz="1300" spc="-1" strike="noStrike">
                <a:solidFill>
                  <a:srgbClr val="000000"/>
                </a:solidFill>
                <a:latin typeface="TrebuchetMS-Bold"/>
                <a:ea typeface="TrebuchetMS-Bold"/>
              </a:rPr>
              <a:t>Results of voltage-guided Ablation :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2000"/>
              </a:lnSpc>
              <a:tabLst>
                <a:tab algn="l" pos="0"/>
                <a:tab algn="l" pos="355680"/>
                <a:tab algn="l" pos="711360"/>
                <a:tab algn="l" pos="1065240"/>
                <a:tab algn="l" pos="1420920"/>
                <a:tab algn="l" pos="1778040"/>
                <a:tab algn="l" pos="2133720"/>
                <a:tab algn="l" pos="2487600"/>
                <a:tab algn="l" pos="2843280"/>
                <a:tab algn="l" pos="3200400"/>
                <a:tab algn="l" pos="3556080"/>
                <a:tab algn="l" pos="3911760"/>
                <a:tab algn="l" pos="426564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fr-FR" sz="1300" spc="-1" strike="noStrike">
                <a:solidFill>
                  <a:srgbClr val="000000"/>
                </a:solidFill>
                <a:latin typeface="TrebuchetMS-Bold"/>
                <a:ea typeface="TrebuchetMS-Bold"/>
              </a:rPr>
              <a:t>Median follow-up : 38.1 </a:t>
            </a:r>
            <a:r>
              <a:rPr b="1" lang="en-US" sz="1300" spc="-1" strike="noStrike">
                <a:solidFill>
                  <a:srgbClr val="000000"/>
                </a:solidFill>
                <a:latin typeface="TrebuchetMS-Bold"/>
                <a:ea typeface="Calibri"/>
              </a:rPr>
              <a:t>[</a:t>
            </a:r>
            <a:r>
              <a:rPr b="1" lang="fr-FR" sz="1300" spc="-1" strike="noStrike">
                <a:solidFill>
                  <a:srgbClr val="000000"/>
                </a:solidFill>
                <a:latin typeface="TrebuchetMS-Bold"/>
                <a:ea typeface="TrebuchetMS-Bold"/>
              </a:rPr>
              <a:t>34.8-41.4</a:t>
            </a:r>
            <a:r>
              <a:rPr b="1" lang="en-US" sz="1300" spc="-1" strike="noStrike">
                <a:solidFill>
                  <a:srgbClr val="000000"/>
                </a:solidFill>
                <a:latin typeface="TrebuchetMS-Bold"/>
                <a:ea typeface="Calibri"/>
              </a:rPr>
              <a:t>] months</a:t>
            </a:r>
            <a:r>
              <a:rPr b="1" lang="fr-FR" sz="1300" spc="-1" strike="noStrike">
                <a:solidFill>
                  <a:srgbClr val="000000"/>
                </a:solidFill>
                <a:latin typeface="TrebuchetMS-Bold"/>
                <a:ea typeface="TrebuchetMS-Bold"/>
              </a:rPr>
              <a:t>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2"/>
          <p:cNvSpPr/>
          <p:nvPr/>
        </p:nvSpPr>
        <p:spPr>
          <a:xfrm>
            <a:off x="4530600" y="5746680"/>
            <a:ext cx="1008360" cy="576360"/>
          </a:xfrm>
          <a:prstGeom prst="rightArrow">
            <a:avLst>
              <a:gd name="adj1" fmla="val 50000"/>
              <a:gd name="adj2" fmla="val 43738"/>
            </a:avLst>
          </a:prstGeom>
          <a:noFill/>
          <a:ln w="63360">
            <a:solidFill>
              <a:srgbClr val="0070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3"/>
          <p:cNvSpPr/>
          <p:nvPr/>
        </p:nvSpPr>
        <p:spPr>
          <a:xfrm>
            <a:off x="2798640" y="1974960"/>
            <a:ext cx="1224000" cy="647640"/>
          </a:xfrm>
          <a:prstGeom prst="roundRect">
            <a:avLst>
              <a:gd name="adj" fmla="val 241"/>
            </a:avLst>
          </a:prstGeom>
          <a:noFill/>
          <a:ln w="6336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0840" bIns="45000" anchor="ctr">
            <a:normAutofit/>
          </a:bodyPr>
          <a:p>
            <a:pPr algn="ctr"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Ob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n=6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AutoShape 4"/>
          <p:cNvSpPr/>
          <p:nvPr/>
        </p:nvSpPr>
        <p:spPr>
          <a:xfrm>
            <a:off x="5624640" y="1963800"/>
            <a:ext cx="1584360" cy="647640"/>
          </a:xfrm>
          <a:prstGeom prst="roundRect">
            <a:avLst>
              <a:gd name="adj" fmla="val 241"/>
            </a:avLst>
          </a:prstGeom>
          <a:noFill/>
          <a:ln w="6336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0840" bIns="45000" anchor="ctr">
            <a:normAutofit/>
          </a:bodyPr>
          <a:p>
            <a:pPr algn="ctr"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Non-obe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n=7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AutoShape 5"/>
          <p:cNvSpPr/>
          <p:nvPr/>
        </p:nvSpPr>
        <p:spPr>
          <a:xfrm>
            <a:off x="1944720" y="819000"/>
            <a:ext cx="5904000" cy="621000"/>
          </a:xfrm>
          <a:prstGeom prst="roundRect">
            <a:avLst>
              <a:gd name="adj" fmla="val 273"/>
            </a:avLst>
          </a:prstGeom>
          <a:noFill/>
          <a:ln w="6336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0840" bIns="45000" anchor="ctr">
            <a:normAutofit/>
          </a:bodyPr>
          <a:p>
            <a:pPr algn="ctr"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Persistent atrial fibrillation patients : 1</a:t>
            </a:r>
            <a:r>
              <a:rPr b="1" lang="fr-FR" sz="1800" spc="-1" strike="noStrike" baseline="33000">
                <a:solidFill>
                  <a:srgbClr val="000000"/>
                </a:solidFill>
                <a:latin typeface="Arial"/>
              </a:rPr>
              <a:t>st</a:t>
            </a: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  proced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n=13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6"/>
          <p:cNvSpPr/>
          <p:nvPr/>
        </p:nvSpPr>
        <p:spPr>
          <a:xfrm flipH="1">
            <a:off x="3560760" y="1440000"/>
            <a:ext cx="363600" cy="51120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7"/>
          <p:cNvSpPr/>
          <p:nvPr/>
        </p:nvSpPr>
        <p:spPr>
          <a:xfrm>
            <a:off x="5904000" y="1440000"/>
            <a:ext cx="431640" cy="52380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8" descr=""/>
          <p:cNvPicPr/>
          <p:nvPr/>
        </p:nvPicPr>
        <p:blipFill>
          <a:blip r:embed="rId1"/>
          <a:stretch/>
        </p:blipFill>
        <p:spPr>
          <a:xfrm>
            <a:off x="71280" y="3024360"/>
            <a:ext cx="1731960" cy="16524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9" descr=""/>
          <p:cNvPicPr/>
          <p:nvPr/>
        </p:nvPicPr>
        <p:blipFill>
          <a:blip r:embed="rId2"/>
          <a:stretch/>
        </p:blipFill>
        <p:spPr>
          <a:xfrm>
            <a:off x="8267760" y="3024360"/>
            <a:ext cx="1731960" cy="1652400"/>
          </a:xfrm>
          <a:prstGeom prst="rect">
            <a:avLst/>
          </a:prstGeom>
          <a:ln w="0">
            <a:noFill/>
          </a:ln>
        </p:spPr>
      </p:pic>
      <p:sp>
        <p:nvSpPr>
          <p:cNvPr id="57" name="AutoShape 10"/>
          <p:cNvSpPr/>
          <p:nvPr/>
        </p:nvSpPr>
        <p:spPr>
          <a:xfrm>
            <a:off x="647640" y="42840"/>
            <a:ext cx="8856720" cy="647640"/>
          </a:xfrm>
          <a:prstGeom prst="roundRect">
            <a:avLst>
              <a:gd name="adj" fmla="val 241"/>
            </a:avLst>
          </a:prstGeom>
          <a:noFill/>
          <a:ln w="6336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0840" bIns="45000" anchor="ctr">
            <a:normAutofit/>
          </a:bodyPr>
          <a:p>
            <a:pPr algn="ctr"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Left atrial remodeling in obese patient : Results of Voltage-guided abl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11"/>
          <p:cNvSpPr/>
          <p:nvPr/>
        </p:nvSpPr>
        <p:spPr>
          <a:xfrm>
            <a:off x="1938240" y="2852640"/>
            <a:ext cx="6193080" cy="1963800"/>
          </a:xfrm>
          <a:prstGeom prst="roundRect">
            <a:avLst>
              <a:gd name="adj" fmla="val 93"/>
            </a:avLst>
          </a:prstGeom>
          <a:noFill/>
          <a:ln w="63360">
            <a:solidFill>
              <a:srgbClr val="007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rmAutofit fontScale="95000"/>
          </a:bodyPr>
          <a:p>
            <a:pPr marL="205200" indent="-205200" algn="just"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marL="205200" indent="-205200" algn="just">
              <a:lnSpc>
                <a:spcPct val="140000"/>
              </a:lnSpc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Calibri"/>
              </a:rPr>
              <a:t>Obese were  younger (p&lt;0.01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marL="205200" indent="-205200" algn="just">
              <a:lnSpc>
                <a:spcPct val="140000"/>
              </a:lnSpc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Calibri"/>
              </a:rPr>
              <a:t>No difference in epicardial atrial tissue (EAT) thicknes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marL="205200" indent="-205200">
              <a:lnSpc>
                <a:spcPct val="140000"/>
              </a:lnSpc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Calibri"/>
              </a:rPr>
              <a:t>LVZ less frequent in obese, particularly on anterior wal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marL="205200" indent="-205200">
              <a:lnSpc>
                <a:spcPct val="140000"/>
              </a:lnSpc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Calibri"/>
              </a:rPr>
              <a:t>Correlation:  EAT and  LVZ extent in obese for posterior and lateral walls.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marL="205200" indent="-205200">
              <a:lnSpc>
                <a:spcPct val="140000"/>
              </a:lnSpc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Calibri"/>
              </a:rPr>
              <a:t>Lateral EAT and P-wave duration = predictors of AF recurrence after ablation.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marL="205200" indent="-205200"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Image 1" descr=""/>
          <p:cNvPicPr/>
          <p:nvPr/>
        </p:nvPicPr>
        <p:blipFill>
          <a:blip r:embed="rId3"/>
          <a:stretch/>
        </p:blipFill>
        <p:spPr>
          <a:xfrm>
            <a:off x="5624640" y="4856040"/>
            <a:ext cx="3625560" cy="270360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8-02T19:31:26Z</dcterms:created>
  <dc:creator>Halim MARZAK</dc:creator>
  <dc:description/>
  <dc:language>en-US</dc:language>
  <cp:lastModifiedBy>MARZAK Halim</cp:lastModifiedBy>
  <dcterms:modified xsi:type="dcterms:W3CDTF">2023-06-30T05:52:09Z</dcterms:modified>
  <cp:revision>6</cp:revision>
  <dc:subject/>
  <dc:title>Présentation PowerPoint</dc:title>
</cp:coreProperties>
</file>